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661C56-99AA-4CDC-ACF3-3EDE194BDF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8393BA-A4A9-4569-8A36-BC9A6EA7A4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DE1F95-8FB5-4173-9311-2F205EB53C3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772AD0-A4B1-453D-98BB-C1BCFD2E341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528D44-BA43-4221-9D02-30EA2FFB7B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3B2D69-53FD-45E4-AF8C-7D2B283B50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9FD370-D3D8-470B-9D71-DE0C348D99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344ECE-CFC2-4983-9754-E6498B1AB0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DF0E6A-BC7D-4117-B763-9823C4105A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110CA7-2B04-4F0A-B90D-AB3BB0E619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245F9F-96AF-4EFC-9FC0-0882E206F5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36FACB-C165-451E-83D2-6856A63209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B94D0C-8C23-4A30-BB9F-4AC81149FF99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332000" y="1341360"/>
          <a:ext cx="6554880" cy="3733920"/>
        </p:xfrm>
        <a:graphic>
          <a:graphicData uri="http://schemas.openxmlformats.org/drawingml/2006/table">
            <a:tbl>
              <a:tblPr/>
              <a:tblGrid>
                <a:gridCol w="644400"/>
                <a:gridCol w="2409840"/>
                <a:gridCol w="2413080"/>
                <a:gridCol w="1087560"/>
              </a:tblGrid>
              <a:tr h="370080">
                <a:tc gridSpan="4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imers for genomic DNA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96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mx1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mplicon siz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base pair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xon 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GGAGGCCTTAGCACATAA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CAGAAGGAGGATGCTCTAG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7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1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xon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CCTATCGAGAGCAGGTTTG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CGAGATTTACTGGCCTTT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7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xon 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GTTGAAGGTCCTCTTGC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AATTGCCTTGCCATAGAC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6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xon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 CATCTGGGGAATATGGCAT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ACGCAGCCCTTTAATATC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xon 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CACCCAGGAAATGGTTTA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CTTCGCTTCTCCCTTCCT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xon 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GTGTGTTTCCTGGACAG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TACCTACAGCCCAGTCTTCA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xon 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AAGCTGGGTTGGAAAGGA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GAAAAATGAGAAGCCCACA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xon 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TCAAACACTTGTTGAGGTC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TAAACAACAGCATCCCAA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8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2"/>
          <p:cNvSpPr/>
          <p:nvPr/>
        </p:nvSpPr>
        <p:spPr>
          <a:xfrm>
            <a:off x="649440" y="309600"/>
            <a:ext cx="464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1: genomic DN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12T13:24:10Z</dcterms:created>
  <dc:creator>bl2</dc:creator>
  <dc:description/>
  <dc:language>en-US</dc:language>
  <cp:lastModifiedBy>bl2</cp:lastModifiedBy>
  <dcterms:modified xsi:type="dcterms:W3CDTF">2012-07-12T13:28:11Z</dcterms:modified>
  <cp:revision>1</cp:revision>
  <dc:subject/>
  <dc:title>PowerPoint Presentation</dc:title>
</cp:coreProperties>
</file>